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ableStyles.xml" ContentType="application/vnd.openxmlformats-officedocument.presentationml.tableStyles+xml"/>
  <Override PartName="/docProps/app.xml" ContentType="application/vnd.openxmlformats-officedocument.extended-properties+xml"/>
  <Override PartName="/docProps/core.xml" ContentType="application/vnd.openxmlformats-package.core-properties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00" autoAdjust="0"/>
    <p:restoredTop sz="94660"/>
  </p:normalViewPr>
  <p:slideViewPr>
    <p:cSldViewPr snapToGrid="0">
      <p:cViewPr varScale="1">
        <p:scale>
          <a:sx n="87" d="100"/>
          <a:sy n="87" d="100"/>
        </p:scale>
        <p:origin x="80" y="8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2.xml"/><Relationship Id="rId3" Type="http://schemas.openxmlformats.org/officeDocument/2006/relationships/presProps" Target="presProps.xml"/><Relationship Id="rId7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Relationship Id="rId9" Type="http://schemas.openxmlformats.org/officeDocument/2006/relationships/customXml" Target="../customXml/item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CBD339-C323-775E-F307-0E5A7D2365B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54538DF3-60B5-FE80-B0AA-5986FA5904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D19F4C-3058-C0CA-894C-1E758FD37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C1AB792-7F41-BD36-FA62-48664924EB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39B7CE-13F0-1FC2-AC9F-E812ED6EEB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8952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071D25-EA2D-EF5D-1900-8C21A2BCE7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859D4F5-4933-2F83-203A-37F9C61923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19A97A2-0840-A869-469F-F3A0ACC1D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A302726-00A0-ACEF-6A63-5A8F8F4DF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B03725E-B015-AC10-D5EB-71EB1636D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42551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9D1B2FD-1969-9C1D-785A-7FCF24537C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C3B5142-92E9-E485-FB06-057137565E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5BFF024-07FC-6171-DF82-4D355DDCA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90526D0-F7F9-FAFC-077E-A81E057740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ADC7B6D-ECD2-CC61-9D2B-B86F6A6476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4771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05EA8F-8CBE-0F26-B153-9C88D43751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31ACB70-1635-7E5B-DDEA-A20AD22921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4A9CA21-9C5E-C649-B844-B7253D1CB0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74C636D-77B7-0582-E44D-9BB7EDDC7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BAA9D4B-EAC4-2D80-E28B-E2E8B0CDD7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67535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76333DB-0460-92EB-B394-13C5A5FAE3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060D3AE-D0E5-B236-3C11-B0F72A61D1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BC06BD-31A1-EAF8-C175-5E2FE003BA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90661E-713C-17F4-91FC-6F5A95BB94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69EE93-BC46-845A-C70C-2C77EB32EF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3525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12847FE-47EE-591C-D9A8-F88CC8EFC6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08BAC38-3980-0EC5-7AA8-8A800BDFD1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E9DF9C8-548D-F45F-57D8-64034368C3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DDCA114-0279-138C-818E-93BFE81BBB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FBCE686-5FE6-F356-76AD-50A655651D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4A5A4F2-F793-11AB-7CC9-5F08FA0803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13041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54B4B01-BDCF-3156-3A74-7971572808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05B33FA-618C-3DDE-1929-C6AFB5D6FE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1BCF52F-10BA-9643-A535-B4BC17B292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CC127BE-0066-0528-E9FD-306B1AF0352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DEB9545-16B6-61F7-E7FB-A0D89C33C92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E129382-640E-766D-A434-E560B5D514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BF791EFA-6F50-0EC5-1888-E87D8FB9F6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7B43867-0A59-FD06-A9B3-095579EA87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841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979571F-0C57-1B5B-8480-BC562C3691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878E19BE-73C6-AA08-7EA5-7BD8BFF10E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0BBFB900-39EA-1737-1D7C-26CD38C67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753402F-C704-AD28-86BA-3B6134B8C5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33928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F30EE33-E284-BA3D-BEF0-43E592786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EBE265E-168B-EE08-89C1-F16948C816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E81EF64-0D36-1C3B-B32E-C54E17C21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55950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AC53F4-BB43-33B0-00D9-8E59CC500B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A73C67-CBCB-170F-D076-26AD8056B7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D99D780-B23D-C1EB-D96C-334FCA4A49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1C8B011-921A-A6FC-3400-2A55C26491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415BC64-52D2-141E-CAD8-B07204A607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9D5BD3D-BAF4-5B5F-41C7-61343A9F4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6996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E9B1E8-9E51-8278-4FE7-77F14F5D62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97271E63-F788-7FC6-C315-605E3E8DB1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D9D484CE-E51D-48FB-0E54-FD02804FE1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88B8FCD-E3B1-439F-94C0-0DC408117B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5DB743D-CEC3-6ED1-4A38-960C717CF4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AACB196-5EB6-D6C7-D2FE-F429D369B4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3412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66E6AFE-2610-CB7A-DE2F-EB1112114E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ECAC945-8E8C-0655-78B5-2F69D3B76C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7708A2-F45A-B889-7990-D9FDC84F73C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A20078-1B9D-4B1A-A870-88A7973D7948}" type="datetimeFigureOut">
              <a:rPr kumimoji="1" lang="ja-JP" altLang="en-US" smtClean="0"/>
              <a:t>2026/3/3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3072941-99CB-3696-68F7-CA7E45670B1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7DE35FF-0801-455C-D4DB-13079048F5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AE548D-2086-4E61-9883-FD3E6A30F58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0901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1624972-9DB5-1664-132A-E2658D815896}"/>
              </a:ext>
            </a:extLst>
          </p:cNvPr>
          <p:cNvSpPr txBox="1"/>
          <p:nvPr/>
        </p:nvSpPr>
        <p:spPr>
          <a:xfrm>
            <a:off x="1722846" y="5943847"/>
            <a:ext cx="7530882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1000"/>
              </a:spcAft>
            </a:pPr>
            <a:r>
              <a:rPr lang="en-US" altLang="ja-JP" sz="1400" b="1" dirty="0">
                <a:effectLst/>
                <a:latin typeface="Times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 S3. Distribution of coefficients of variation (CVs) across blood contamination levels</a:t>
            </a:r>
            <a:endParaRPr lang="ja-JP" altLang="ja-JP" sz="1400" b="1" dirty="0">
              <a:effectLst/>
              <a:latin typeface="Times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32637300-AFCE-5D7E-4490-A20DCAE061B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22846" y="87537"/>
            <a:ext cx="8504657" cy="56880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87732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ドキュメント" ma:contentTypeID="0x01010034E485A41FBE0840AEF03DC6126CF7E9" ma:contentTypeVersion="10" ma:contentTypeDescription="新しいドキュメントを作成します。" ma:contentTypeScope="" ma:versionID="b7fc72b48302197a3c00e12c5a71d0f2">
  <xsd:schema xmlns:xsd="http://www.w3.org/2001/XMLSchema" xmlns:xs="http://www.w3.org/2001/XMLSchema" xmlns:p="http://schemas.microsoft.com/office/2006/metadata/properties" xmlns:ns2="09e658bc-5f5e-48b2-a593-8f2a4dff4e86" targetNamespace="http://schemas.microsoft.com/office/2006/metadata/properties" ma:root="true" ma:fieldsID="3811df9a92dabbc9fbde200746e96434" ns2:_="">
    <xsd:import namespace="09e658bc-5f5e-48b2-a593-8f2a4dff4e86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  <xsd:element ref="ns2:MediaServiceDateTake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9e658bc-5f5e-48b2-a593-8f2a4dff4e8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画像タグ" ma:readOnly="false" ma:fieldId="{5cf76f15-5ced-4ddc-b409-7134ff3c332f}" ma:taxonomyMulti="true" ma:sspId="559d5a2e-65d4-4456-94da-aa20a3af47a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2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6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コンテンツ タイプ"/>
        <xsd:element ref="dc:title" minOccurs="0" maxOccurs="1" ma:index="4" ma:displayName="タイトル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09e658bc-5f5e-48b2-a593-8f2a4dff4e86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5ED60F9E-FFBD-43CD-B821-8DAE12A04E5E}"/>
</file>

<file path=customXml/itemProps2.xml><?xml version="1.0" encoding="utf-8"?>
<ds:datastoreItem xmlns:ds="http://schemas.openxmlformats.org/officeDocument/2006/customXml" ds:itemID="{457259AE-175C-4806-81B2-287EDE67B65B}"/>
</file>

<file path=customXml/itemProps3.xml><?xml version="1.0" encoding="utf-8"?>
<ds:datastoreItem xmlns:ds="http://schemas.openxmlformats.org/officeDocument/2006/customXml" ds:itemID="{A80181A8-06E7-4027-89C5-BB0091B51372}"/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</Words>
  <Application>Microsoft Office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辰巳　めぐみ</dc:creator>
  <cp:lastModifiedBy>辰巳　めぐみ</cp:lastModifiedBy>
  <cp:revision>1</cp:revision>
  <dcterms:created xsi:type="dcterms:W3CDTF">2026-03-31T01:02:07Z</dcterms:created>
  <dcterms:modified xsi:type="dcterms:W3CDTF">2026-03-31T01:02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4E485A41FBE0840AEF03DC6126CF7E9</vt:lpwstr>
  </property>
</Properties>
</file>